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63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5592" userDrawn="1">
          <p15:clr>
            <a:srgbClr val="A4A3A4"/>
          </p15:clr>
        </p15:guide>
        <p15:guide id="7" orient="horz" pos="5864" userDrawn="1">
          <p15:clr>
            <a:srgbClr val="A4A3A4"/>
          </p15:clr>
        </p15:guide>
        <p15:guide id="12" orient="horz" pos="5660" userDrawn="1">
          <p15:clr>
            <a:srgbClr val="A4A3A4"/>
          </p15:clr>
        </p15:guide>
        <p15:guide id="25" orient="horz" pos="5774" userDrawn="1">
          <p15:clr>
            <a:srgbClr val="A4A3A4"/>
          </p15:clr>
        </p15:guide>
        <p15:guide id="26" orient="horz" pos="3165" userDrawn="1">
          <p15:clr>
            <a:srgbClr val="A4A3A4"/>
          </p15:clr>
        </p15:guide>
        <p15:guide id="28" pos="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12EFF"/>
    <a:srgbClr val="0C1FFF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093"/>
    <p:restoredTop sz="94784"/>
  </p:normalViewPr>
  <p:slideViewPr>
    <p:cSldViewPr snapToGrid="0" snapToObjects="1" showGuides="1">
      <p:cViewPr varScale="1">
        <p:scale>
          <a:sx n="73" d="100"/>
          <a:sy n="73" d="100"/>
        </p:scale>
        <p:origin x="1800" y="200"/>
      </p:cViewPr>
      <p:guideLst>
        <p:guide orient="horz" pos="5592"/>
        <p:guide orient="horz" pos="5864"/>
        <p:guide orient="horz" pos="5660"/>
        <p:guide orient="horz" pos="5774"/>
        <p:guide orient="horz" pos="3165"/>
        <p:guide pos="9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BE6B608-BC91-5547-A99C-95BBB60F622E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D96DDD-CF23-4749-B965-79BCA593D0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802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761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5063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940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388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691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1560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6883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793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617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5862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9178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9F1BAF-6824-2649-A6A8-E9AE73C5C51F}" type="datetimeFigureOut">
              <a:rPr kumimoji="1" lang="ja-JP" altLang="en-US" smtClean="0"/>
              <a:t>2023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3248FC-A106-524F-840B-E29AA66472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2397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7282D069-8A98-4441-B1D2-7EF0EB7EBC5F}"/>
              </a:ext>
            </a:extLst>
          </p:cNvPr>
          <p:cNvSpPr/>
          <p:nvPr/>
        </p:nvSpPr>
        <p:spPr>
          <a:xfrm>
            <a:off x="444716" y="7868194"/>
            <a:ext cx="5979476" cy="1634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ja-JP" sz="8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</a:rPr>
              <a:t>Table supplement 1. Comparison of the cellular component included only in the P1 fraction, only in the P2 fraction, and both in the P1 and P2 fraction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ja-JP" sz="8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</a:rPr>
              <a:t>Proteins identified by the quantitative proteomic analysis in the P1 and P2 fraction were divided into the 3 groups (proteins detected only in the P1 fraction, proteins detected only in the P2 fraction, and proteins detected both in the P1 and P2 fraction). Proteins annotated with a specific term of “Cellular component” were counted and categorized into their “Cellular component” group, and the percent of the count of proteins with a specific term to the total count of proteins was calculated by DAVID software.</a:t>
            </a:r>
            <a:endParaRPr lang="ja-JP" altLang="ja-JP" sz="800" kern="100">
              <a:latin typeface="Times New Roman" panose="02020603050405020304" pitchFamily="18" charset="0"/>
              <a:ea typeface="ＭＳ 明朝" panose="02020609040205080304" pitchFamily="49" charset="-128"/>
            </a:endParaRPr>
          </a:p>
        </p:txBody>
      </p:sp>
      <p:sp>
        <p:nvSpPr>
          <p:cNvPr id="20" name="テキスト ボックス 1">
            <a:extLst>
              <a:ext uri="{FF2B5EF4-FFF2-40B4-BE49-F238E27FC236}">
                <a16:creationId xmlns:a16="http://schemas.microsoft.com/office/drawing/2014/main" id="{98383A98-CDF1-1346-BE59-AE296EB1C764}"/>
              </a:ext>
            </a:extLst>
          </p:cNvPr>
          <p:cNvSpPr txBox="1"/>
          <p:nvPr/>
        </p:nvSpPr>
        <p:spPr>
          <a:xfrm>
            <a:off x="4790126" y="0"/>
            <a:ext cx="20678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u="sng" dirty="0"/>
              <a:t>Table Supplement</a:t>
            </a:r>
            <a:r>
              <a:rPr kumimoji="1" lang="en-US" altLang="ja-JP" b="1" u="sng" dirty="0"/>
              <a:t> 1</a:t>
            </a:r>
            <a:endParaRPr kumimoji="1" lang="ja-JP" altLang="en-US" u="sng"/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D07E32EA-8AEC-0544-9AB7-8C1888737F3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1797" y="311244"/>
            <a:ext cx="4040909" cy="7631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06649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2893</TotalTime>
  <Words>127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ＭＳ 明朝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中 良法</dc:creator>
  <cp:lastModifiedBy>田中 良法</cp:lastModifiedBy>
  <cp:revision>767</cp:revision>
  <cp:lastPrinted>2022-11-14T06:44:26Z</cp:lastPrinted>
  <dcterms:created xsi:type="dcterms:W3CDTF">2021-12-14T05:07:59Z</dcterms:created>
  <dcterms:modified xsi:type="dcterms:W3CDTF">2023-03-12T11:04:29Z</dcterms:modified>
</cp:coreProperties>
</file>